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4" r:id="rId4"/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1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9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01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637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21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357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200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33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139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96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794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619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662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media" Target="../media/media2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10.png"/><Relationship Id="rId4" Type="http://schemas.openxmlformats.org/officeDocument/2006/relationships/video" Target="../media/media2.avi"/><Relationship Id="rId9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media" Target="../media/media5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6" Type="http://schemas.openxmlformats.org/officeDocument/2006/relationships/video" Target="../media/media6.avi"/><Relationship Id="rId5" Type="http://schemas.microsoft.com/office/2007/relationships/media" Target="../media/media6.avi"/><Relationship Id="rId10" Type="http://schemas.openxmlformats.org/officeDocument/2006/relationships/image" Target="../media/image13.png"/><Relationship Id="rId4" Type="http://schemas.openxmlformats.org/officeDocument/2006/relationships/video" Target="../media/media5.avi"/><Relationship Id="rId9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smtClean="0"/>
              <a:t>AZD4547+Sunitinib</a:t>
            </a:r>
            <a:endParaRPr lang="en-US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870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528" y="2185416"/>
            <a:ext cx="1965960" cy="196596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de-CH" b="1" dirty="0" err="1" smtClean="0"/>
              <a:t>Combination</a:t>
            </a:r>
            <a:r>
              <a:rPr lang="de-CH" b="1" dirty="0" smtClean="0"/>
              <a:t>: </a:t>
            </a:r>
            <a:r>
              <a:rPr lang="de-CH" b="1" dirty="0" err="1" smtClean="0"/>
              <a:t>blood</a:t>
            </a:r>
            <a:r>
              <a:rPr lang="de-CH" b="1" dirty="0" smtClean="0"/>
              <a:t> </a:t>
            </a:r>
            <a:r>
              <a:rPr lang="de-CH" b="1" dirty="0" err="1" smtClean="0"/>
              <a:t>vessel</a:t>
            </a:r>
            <a:r>
              <a:rPr lang="de-CH" b="1" dirty="0" smtClean="0"/>
              <a:t> </a:t>
            </a:r>
            <a:r>
              <a:rPr lang="de-CH" b="1" dirty="0" err="1" smtClean="0"/>
              <a:t>growth</a:t>
            </a:r>
            <a:endParaRPr lang="de-CH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943872" y="18122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4" name="TextBox 3"/>
          <p:cNvSpPr txBox="1"/>
          <p:nvPr/>
        </p:nvSpPr>
        <p:spPr>
          <a:xfrm>
            <a:off x="624462" y="181451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3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5" name="TextBox 4"/>
          <p:cNvSpPr txBox="1"/>
          <p:nvPr/>
        </p:nvSpPr>
        <p:spPr>
          <a:xfrm>
            <a:off x="2783375" y="18122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2" name="TextBox 11"/>
          <p:cNvSpPr txBox="1"/>
          <p:nvPr/>
        </p:nvSpPr>
        <p:spPr>
          <a:xfrm>
            <a:off x="7052789" y="182767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3" name="TextBox 12"/>
          <p:cNvSpPr txBox="1"/>
          <p:nvPr/>
        </p:nvSpPr>
        <p:spPr>
          <a:xfrm>
            <a:off x="9219093" y="181112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8" name="TextBox 17"/>
          <p:cNvSpPr txBox="1"/>
          <p:nvPr/>
        </p:nvSpPr>
        <p:spPr>
          <a:xfrm>
            <a:off x="624462" y="428950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6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9" name="TextBox 18"/>
          <p:cNvSpPr txBox="1"/>
          <p:nvPr/>
        </p:nvSpPr>
        <p:spPr>
          <a:xfrm>
            <a:off x="2783375" y="428725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8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21" name="TextBox 20"/>
          <p:cNvSpPr txBox="1"/>
          <p:nvPr/>
        </p:nvSpPr>
        <p:spPr>
          <a:xfrm>
            <a:off x="786407" y="2245361"/>
            <a:ext cx="819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>
                <a:solidFill>
                  <a:schemeClr val="bg1"/>
                </a:solidFill>
              </a:rPr>
              <a:t>P</a:t>
            </a:r>
            <a:r>
              <a:rPr lang="de-CH" sz="1400" dirty="0" smtClean="0">
                <a:solidFill>
                  <a:schemeClr val="bg1"/>
                </a:solidFill>
              </a:rPr>
              <a:t>roximal</a:t>
            </a:r>
            <a:endParaRPr lang="de-CH" sz="1400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55214" y="2241495"/>
            <a:ext cx="5924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>
                <a:solidFill>
                  <a:schemeClr val="bg1"/>
                </a:solidFill>
              </a:rPr>
              <a:t>D</a:t>
            </a:r>
            <a:r>
              <a:rPr lang="de-CH" sz="1400" dirty="0" smtClean="0">
                <a:solidFill>
                  <a:schemeClr val="bg1"/>
                </a:solidFill>
              </a:rPr>
              <a:t>istal</a:t>
            </a:r>
            <a:endParaRPr lang="de-CH" sz="1400" dirty="0">
              <a:solidFill>
                <a:schemeClr val="bg1"/>
              </a:solidFill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3512" y="2185416"/>
            <a:ext cx="1965960" cy="196596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7483" y="2180460"/>
            <a:ext cx="1965960" cy="196596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1454" y="2172188"/>
            <a:ext cx="1965960" cy="196596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5425" y="2197004"/>
            <a:ext cx="1965960" cy="196596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724" y="4672000"/>
            <a:ext cx="1965960" cy="196596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2523" y="4672000"/>
            <a:ext cx="1965960" cy="196596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a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2063545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erfusion (Videos)</a:t>
            </a:r>
            <a:endParaRPr lang="en-US" b="1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3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4" name="Oval 13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5" name="Oval 14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6" name="TextBox 15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pic>
        <p:nvPicPr>
          <p:cNvPr id="18" name="4b_perfusion">
            <a:hlinkClick r:id="" action="ppaction://media"/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7200" y="2560320"/>
            <a:ext cx="3291839" cy="3291840"/>
          </a:xfrm>
        </p:spPr>
      </p:pic>
      <p:pic>
        <p:nvPicPr>
          <p:cNvPr id="19" name="6_perfusion">
            <a:hlinkClick r:id="" action="ppaction://media"/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</p:spPr>
      </p:pic>
      <p:pic>
        <p:nvPicPr>
          <p:cNvPr id="20" name="8_perfusion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0" y="2560320"/>
            <a:ext cx="3291839" cy="329184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b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27456848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9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 smtClean="0"/>
              <a:t>Perfused </a:t>
            </a:r>
            <a:r>
              <a:rPr lang="en-US" b="1" dirty="0"/>
              <a:t>Z-stack (Videos)</a:t>
            </a:r>
            <a:endParaRPr lang="en-US" b="1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7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1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Oval 11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3" name="Oval 12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4" name="TextBox 13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pic>
        <p:nvPicPr>
          <p:cNvPr id="16" name="4.5_dpt_perfused_Zstack_movie">
            <a:hlinkClick r:id="" action="ppaction://media"/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7200" y="2560320"/>
            <a:ext cx="3291839" cy="3291840"/>
          </a:xfrm>
        </p:spPr>
      </p:pic>
      <p:pic>
        <p:nvPicPr>
          <p:cNvPr id="17" name="6.5_dpt_movie">
            <a:hlinkClick r:id="" action="ppaction://media"/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</p:spPr>
      </p:pic>
      <p:pic>
        <p:nvPicPr>
          <p:cNvPr id="18" name="8.0_dpt_movie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0" y="2560320"/>
            <a:ext cx="3291839" cy="329184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c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24174598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6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6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8</TotalTime>
  <Words>54</Words>
  <Application>Microsoft Office PowerPoint</Application>
  <PresentationFormat>Widescreen</PresentationFormat>
  <Paragraphs>26</Paragraphs>
  <Slides>4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AZD4547+Sunitinib</vt:lpstr>
      <vt:lpstr>Combination: blood vessel growth</vt:lpstr>
      <vt:lpstr>Perfusion (Videos)</vt:lpstr>
      <vt:lpstr>Perfused Z-stack (Videos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bination</dc:title>
  <dc:creator>martin.k.sch@outlook.com</dc:creator>
  <cp:lastModifiedBy>martin.k.sch@outlook.com</cp:lastModifiedBy>
  <cp:revision>17</cp:revision>
  <dcterms:created xsi:type="dcterms:W3CDTF">2018-09-02T13:57:35Z</dcterms:created>
  <dcterms:modified xsi:type="dcterms:W3CDTF">2018-10-29T15:11:05Z</dcterms:modified>
</cp:coreProperties>
</file>